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2" r:id="rId3"/>
    <p:sldId id="261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46" autoAdjust="0"/>
    <p:restoredTop sz="94660"/>
  </p:normalViewPr>
  <p:slideViewPr>
    <p:cSldViewPr snapToGrid="0">
      <p:cViewPr varScale="1">
        <p:scale>
          <a:sx n="83" d="100"/>
          <a:sy n="83" d="100"/>
        </p:scale>
        <p:origin x="490" y="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67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881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990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712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895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75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0210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0114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711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487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9581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9FFD5-7D11-43FB-8CB0-340AB6658425}" type="datetimeFigureOut">
              <a:rPr kumimoji="1" lang="ja-JP" altLang="en-US" smtClean="0"/>
              <a:t>2023/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F2F0C-078E-46C3-BF11-4E33D1B637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8922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12" Type="http://schemas.openxmlformats.org/officeDocument/2006/relationships/image" Target="../media/image21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11" Type="http://schemas.openxmlformats.org/officeDocument/2006/relationships/image" Target="../media/image20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12" Type="http://schemas.openxmlformats.org/officeDocument/2006/relationships/image" Target="../media/image1.png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f"/><Relationship Id="rId11" Type="http://schemas.openxmlformats.org/officeDocument/2006/relationships/image" Target="../media/image31.tiff"/><Relationship Id="rId5" Type="http://schemas.openxmlformats.org/officeDocument/2006/relationships/image" Target="../media/image25.tiff"/><Relationship Id="rId10" Type="http://schemas.openxmlformats.org/officeDocument/2006/relationships/image" Target="../media/image30.tiff"/><Relationship Id="rId4" Type="http://schemas.openxmlformats.org/officeDocument/2006/relationships/image" Target="../media/image24.tiff"/><Relationship Id="rId9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4349F3E-5B8D-B636-BA3C-9A04D4437C2C}"/>
              </a:ext>
            </a:extLst>
          </p:cNvPr>
          <p:cNvSpPr txBox="1"/>
          <p:nvPr/>
        </p:nvSpPr>
        <p:spPr>
          <a:xfrm>
            <a:off x="0" y="0"/>
            <a:ext cx="28323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0" dirty="0">
                <a:solidFill>
                  <a:srgbClr val="222222"/>
                </a:solidFill>
                <a:effectLst/>
                <a:latin typeface="-apple-system"/>
              </a:rPr>
              <a:t>Supplementary information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A56068B-A0A1-E4B6-09D4-F628E0935500}"/>
              </a:ext>
            </a:extLst>
          </p:cNvPr>
          <p:cNvSpPr txBox="1"/>
          <p:nvPr/>
        </p:nvSpPr>
        <p:spPr>
          <a:xfrm>
            <a:off x="247349" y="1790360"/>
            <a:ext cx="8649302" cy="3946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omparison of [</a:t>
            </a:r>
            <a:r>
              <a:rPr lang="en-US" altLang="ja-JP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8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F]FIMP, [</a:t>
            </a:r>
            <a:r>
              <a:rPr lang="en-US" altLang="ja-JP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1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C]MET, and [</a:t>
            </a:r>
            <a:r>
              <a:rPr lang="en-US" altLang="ja-JP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18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F]FDG PET for early-phase assessment of radiotherapy response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Satoshi Nozaki, Yuka Nakatani, Aya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Mawatari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, Nina Shibata, William E. Hume, </a:t>
            </a: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Emi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Hayashinaka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, Yasuhiro Wada, Hisashi Doi, and Yasuyoshi Watanabe</a:t>
            </a:r>
            <a:endParaRPr lang="en-US" altLang="ja-JP" sz="1800" kern="100" baseline="300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Arial" panose="020B0604020202020204" pitchFamily="34" charset="0"/>
              </a:rPr>
              <a:t> 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3862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52443FDE-ECAE-EAB8-92E1-E476D4DC0578}"/>
              </a:ext>
            </a:extLst>
          </p:cNvPr>
          <p:cNvGrpSpPr>
            <a:grpSpLocks noChangeAspect="1"/>
          </p:cNvGrpSpPr>
          <p:nvPr/>
        </p:nvGrpSpPr>
        <p:grpSpPr>
          <a:xfrm>
            <a:off x="623251" y="381753"/>
            <a:ext cx="7905308" cy="5399634"/>
            <a:chOff x="71024" y="381740"/>
            <a:chExt cx="8968140" cy="6125592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EBC3739B-9169-B6CD-D86D-16C21FC8117B}"/>
                </a:ext>
              </a:extLst>
            </p:cNvPr>
            <p:cNvSpPr/>
            <p:nvPr/>
          </p:nvSpPr>
          <p:spPr>
            <a:xfrm>
              <a:off x="71024" y="381740"/>
              <a:ext cx="8968140" cy="612559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0D85CDC-527F-33D3-9AE7-1416C96EF9B1}"/>
                </a:ext>
              </a:extLst>
            </p:cNvPr>
            <p:cNvSpPr txBox="1"/>
            <p:nvPr/>
          </p:nvSpPr>
          <p:spPr>
            <a:xfrm>
              <a:off x="1360109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8DB04A6-F983-E5A8-1849-EC05FDCDB6B4}"/>
                </a:ext>
              </a:extLst>
            </p:cNvPr>
            <p:cNvSpPr txBox="1"/>
            <p:nvPr/>
          </p:nvSpPr>
          <p:spPr>
            <a:xfrm>
              <a:off x="2757318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3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6799821-3B3C-C723-1896-E5694C04B6C4}"/>
                </a:ext>
              </a:extLst>
            </p:cNvPr>
            <p:cNvSpPr txBox="1"/>
            <p:nvPr/>
          </p:nvSpPr>
          <p:spPr>
            <a:xfrm>
              <a:off x="4265669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7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D84C0F3-C18D-0599-687C-142B85CBB2BD}"/>
                </a:ext>
              </a:extLst>
            </p:cNvPr>
            <p:cNvSpPr txBox="1"/>
            <p:nvPr/>
          </p:nvSpPr>
          <p:spPr>
            <a:xfrm>
              <a:off x="5623156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0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BC53430-5D7F-F82F-4DB3-A2D53EAF13E5}"/>
                </a:ext>
              </a:extLst>
            </p:cNvPr>
            <p:cNvSpPr txBox="1"/>
            <p:nvPr/>
          </p:nvSpPr>
          <p:spPr>
            <a:xfrm>
              <a:off x="7141727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4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99A477B-8DF1-C002-CEEB-178C23D2A4D5}"/>
                </a:ext>
              </a:extLst>
            </p:cNvPr>
            <p:cNvSpPr txBox="1"/>
            <p:nvPr/>
          </p:nvSpPr>
          <p:spPr>
            <a:xfrm>
              <a:off x="315081" y="1651075"/>
              <a:ext cx="42321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Con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F29236C-39AC-B710-3E2C-99167DB17E69}"/>
                </a:ext>
              </a:extLst>
            </p:cNvPr>
            <p:cNvSpPr txBox="1"/>
            <p:nvPr/>
          </p:nvSpPr>
          <p:spPr>
            <a:xfrm>
              <a:off x="229870" y="4479516"/>
              <a:ext cx="54164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60Gy</a:t>
              </a: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B3D5708-62D0-D91B-5DA0-68D28465655F}"/>
                </a:ext>
              </a:extLst>
            </p:cNvPr>
            <p:cNvSpPr txBox="1"/>
            <p:nvPr/>
          </p:nvSpPr>
          <p:spPr>
            <a:xfrm>
              <a:off x="168916" y="481406"/>
              <a:ext cx="1012063" cy="349702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b="1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r>
                <a:rPr kumimoji="1" lang="en-US" altLang="ja-JP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FIMP</a:t>
              </a:r>
              <a:endParaRPr kumimoji="1" lang="ja-JP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198195AE-D150-C50B-7880-D453887A9AA0}"/>
                </a:ext>
              </a:extLst>
            </p:cNvPr>
            <p:cNvGrpSpPr/>
            <p:nvPr/>
          </p:nvGrpSpPr>
          <p:grpSpPr>
            <a:xfrm>
              <a:off x="8446019" y="4774699"/>
              <a:ext cx="428771" cy="1465757"/>
              <a:chOff x="7726932" y="4295304"/>
              <a:chExt cx="428771" cy="1465757"/>
            </a:xfrm>
          </p:grpSpPr>
          <p:pic>
            <p:nvPicPr>
              <p:cNvPr id="29" name="図 28" descr="color bar.bmp">
                <a:extLst>
                  <a:ext uri="{FF2B5EF4-FFF2-40B4-BE49-F238E27FC236}">
                    <a16:creationId xmlns:a16="http://schemas.microsoft.com/office/drawing/2014/main" id="{0CD46348-A095-32EA-1E23-2296F8FBF3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 rot="16200000">
                <a:off x="7481317" y="5046387"/>
                <a:ext cx="920001" cy="69241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2E6FF59-55BD-8AE7-CE5B-734403C9E2AA}"/>
                  </a:ext>
                </a:extLst>
              </p:cNvPr>
              <p:cNvSpPr txBox="1"/>
              <p:nvPr/>
            </p:nvSpPr>
            <p:spPr>
              <a:xfrm>
                <a:off x="7773818" y="5532537"/>
                <a:ext cx="334996" cy="228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0.2</a:t>
                </a:r>
                <a:endParaRPr lang="ja-JP" altLang="en-US" sz="1050" b="1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64E89EB3-6D9F-BC70-3C1F-B06EA9812D18}"/>
                  </a:ext>
                </a:extLst>
              </p:cNvPr>
              <p:cNvSpPr txBox="1"/>
              <p:nvPr/>
            </p:nvSpPr>
            <p:spPr>
              <a:xfrm>
                <a:off x="7773818" y="4416755"/>
                <a:ext cx="334996" cy="228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2.0</a:t>
                </a:r>
                <a:endParaRPr lang="ja-JP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90F71730-7397-62F2-5081-F52ED2A41523}"/>
                  </a:ext>
                </a:extLst>
              </p:cNvPr>
              <p:cNvSpPr txBox="1"/>
              <p:nvPr/>
            </p:nvSpPr>
            <p:spPr>
              <a:xfrm>
                <a:off x="7726932" y="4295304"/>
                <a:ext cx="428771" cy="2354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10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SUV</a:t>
                </a:r>
                <a:endParaRPr lang="ja-JP" altLang="en-US" sz="110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" name="Picture 3" descr="F:\NagasePJ\X線照射\AA-7\Day 1\160428_Mouse_Body_A03141_CTP0006_Day1-Con_nozaki_F2A\Analysis\160428_Mouse_Body_A03141_CTP0006_Day1-Con_nozaki_F2A_v1_sta_OSEM_ACNoSC_MIP.img_f0_x64_y0_z47_coro SUV0.2-2.0.tif">
              <a:extLst>
                <a:ext uri="{FF2B5EF4-FFF2-40B4-BE49-F238E27FC236}">
                  <a16:creationId xmlns:a16="http://schemas.microsoft.com/office/drawing/2014/main" id="{1C3D7EA8-C6BF-5984-F8C9-3EAD1E3E8CF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1086" y="1270980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5" descr="F:\NagasePJ\X線照射\AA-7\Day 1\160721_Mouse_Body_A03278_CTP0006_Day1-60Gy_nozaki_F2A\Analysis\160721_Mouse_Body_A03278_CTP0006_Day1-60Gy_nozaki_F2A_v1_sta_OSEM_ACNoSC_MIP.img_f0_x64_y0_z47_coro SUV0.2-2.0.tif">
              <a:extLst>
                <a:ext uri="{FF2B5EF4-FFF2-40B4-BE49-F238E27FC236}">
                  <a16:creationId xmlns:a16="http://schemas.microsoft.com/office/drawing/2014/main" id="{A6BA5880-24F8-4B71-D22D-F17A41B2A25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1086" y="3969059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6" descr="F:\NagasePJ\X線照射\AA-7\Day 3\160428_Mouse_Body_A03142_CTP0006_Day3-Con_nozaki_F2B\Analysis\160428_Mouse_Body_A03142_CTP0006_Day3-Con_nozaki_F2B_v1_sta_OSEM_ACNoSC_MIP.img_f0_x64_y0_z47_coro SUV0.2-2.0.tif">
              <a:extLst>
                <a:ext uri="{FF2B5EF4-FFF2-40B4-BE49-F238E27FC236}">
                  <a16:creationId xmlns:a16="http://schemas.microsoft.com/office/drawing/2014/main" id="{AD6DB207-4BD4-6E2F-DC1F-E2CE999CAB8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8295" y="1270980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8" descr="F:\NagasePJ\X線照射\AA-7\Day 3\160715_Mouse_Body_A03259_CTP0006_Day3-60Gy_nozaki_F2B\Analysis\160715_Mouse_Body_A03259_CTP0006_Day3-60Gy_nozaki_F2B_v1_sta_OSEM_ACNoSC_MIP.img_f0_x64_y0_z47_coro SUV0.2-2.0.tif">
              <a:extLst>
                <a:ext uri="{FF2B5EF4-FFF2-40B4-BE49-F238E27FC236}">
                  <a16:creationId xmlns:a16="http://schemas.microsoft.com/office/drawing/2014/main" id="{46A01A95-CF94-E406-C122-2C49839C8D0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8295" y="3969059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1" descr="F:\NagasePJ\X線照射\AA-7\Day 7\160721_Mouse_Body_A03280_CTP0006_Day7-Con_nozaki_F2A\Analysis\160721_Mouse_Body_A03280_CTP0006_Day7-Con_nozaki_F2A_v1_sta_OSEM_ACNoSC_MIP.img_f0_x64_y0_z47_coro SUV0.2-2.0.tif">
              <a:extLst>
                <a:ext uri="{FF2B5EF4-FFF2-40B4-BE49-F238E27FC236}">
                  <a16:creationId xmlns:a16="http://schemas.microsoft.com/office/drawing/2014/main" id="{760B67D0-6B00-EB12-01CF-8E81B6D8F28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76646" y="1270980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3" descr="F:\NagasePJ\X線照射\AA-7\Day 7\160715_Mouse_Body_A03262_CTP0006_Day7-60Gy_nozaki_F2A\Analysis\160715_Mouse_Body_A03262_CTP0006_Day7-60Gy_nozaki_F2A_v1_sta_OSEM_ACNoSC_MIP.img_f0_x64_y0_z47_coro SUV0.2-2.0.tif">
              <a:extLst>
                <a:ext uri="{FF2B5EF4-FFF2-40B4-BE49-F238E27FC236}">
                  <a16:creationId xmlns:a16="http://schemas.microsoft.com/office/drawing/2014/main" id="{FEB05E5B-9446-5BCE-DF86-CFF7AA6723A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76646" y="3969059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5" descr="F:\NagasePJ\X線照射\AA-7\Day 10\160728_Mouse_Body_A03289_CTP0006_Day10-Con_nozaki_F2A\Analysis\160728_Mouse_Body_A03289_CTP0006_Day10-Con_nozaki_F2A_v1_sta_OSEM_ACNoSC_MIP.img_f0_x64_y0_z47_coro SUV0.2-2.0.tif">
              <a:extLst>
                <a:ext uri="{FF2B5EF4-FFF2-40B4-BE49-F238E27FC236}">
                  <a16:creationId xmlns:a16="http://schemas.microsoft.com/office/drawing/2014/main" id="{AEB6518F-3552-EB8D-CFF4-31CBBD5F046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2643" y="1270980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6" descr="F:\NagasePJ\X線照射\AA-7\Day 10\160728_Mouse_Body_A03290_CTP0006_Day10-60Gy_nozaki_F2B\Analysis\160728_Mouse_Body_A03290_CTP0006_Day10-60Gy_nozaki_F2B_v1_sta_OSEM_ACNoSC_MIP.img_f0_x64_y0_z47_coro SUV0.2-2.0.tif">
              <a:extLst>
                <a:ext uri="{FF2B5EF4-FFF2-40B4-BE49-F238E27FC236}">
                  <a16:creationId xmlns:a16="http://schemas.microsoft.com/office/drawing/2014/main" id="{C7DA1F2C-D245-410F-5565-B9A4599E6275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2643" y="3969059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18" descr="F:\NagasePJ\X線照射\AA-7\Day 14\160610_Mouse_Body_A03178_CTP0006_Day14-Con_nozaki_F2B\Analysis\160610_Mouse_Body_A03178_CTP0006_Day14-Con_nozaki_F2B_v1_sta_OSEM_ACNoSC_MIP.img_f0_x64_y0_z47_coro SUV0.2-2.0.tif">
              <a:extLst>
                <a:ext uri="{FF2B5EF4-FFF2-40B4-BE49-F238E27FC236}">
                  <a16:creationId xmlns:a16="http://schemas.microsoft.com/office/drawing/2014/main" id="{0F72726F-38C0-E009-6CD4-AEDCE35F556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1214" y="1270980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20" descr="F:\NagasePJ\X線照射\AA-7\Day 14\160610_Mouse_Body_A03180_CTP0006_Day14-60Gy_nozaki_F2B\Analysis\160610_Mouse_Body_A03180_CTP0006_Day14-60Gy_nozaki_F2B_v1_sta_OSEM_ACNoSC_MIP.img_f0_x64_y0_z47_coro SUV0.2-2.0.tif">
              <a:extLst>
                <a:ext uri="{FF2B5EF4-FFF2-40B4-BE49-F238E27FC236}">
                  <a16:creationId xmlns:a16="http://schemas.microsoft.com/office/drawing/2014/main" id="{81108409-0351-AB37-0635-9F94C028E8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1214" y="3969059"/>
              <a:ext cx="1767014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8996508-3415-A9A1-021A-4FF73BF7B936}"/>
              </a:ext>
            </a:extLst>
          </p:cNvPr>
          <p:cNvSpPr txBox="1"/>
          <p:nvPr/>
        </p:nvSpPr>
        <p:spPr>
          <a:xfrm>
            <a:off x="0" y="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0" dirty="0">
                <a:solidFill>
                  <a:srgbClr val="222222"/>
                </a:solidFill>
                <a:effectLst/>
                <a:latin typeface="-apple-system"/>
              </a:rPr>
              <a:t>Supplementary Figure S1</a:t>
            </a:r>
            <a:endParaRPr kumimoji="1" lang="ja-JP" altLang="en-US" b="1" dirty="0"/>
          </a:p>
        </p:txBody>
      </p:sp>
      <p:sp>
        <p:nvSpPr>
          <p:cNvPr id="19" name="矢印: 右 18">
            <a:extLst>
              <a:ext uri="{FF2B5EF4-FFF2-40B4-BE49-F238E27FC236}">
                <a16:creationId xmlns:a16="http://schemas.microsoft.com/office/drawing/2014/main" id="{CD5890A4-DD3D-1BAD-C62A-D77CD916C8D7}"/>
              </a:ext>
            </a:extLst>
          </p:cNvPr>
          <p:cNvSpPr/>
          <p:nvPr/>
        </p:nvSpPr>
        <p:spPr>
          <a:xfrm rot="9000000">
            <a:off x="2383041" y="1513608"/>
            <a:ext cx="340797" cy="26633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B1FC9756-96D2-A09D-E0CD-7DE85F1E514A}"/>
              </a:ext>
            </a:extLst>
          </p:cNvPr>
          <p:cNvSpPr/>
          <p:nvPr/>
        </p:nvSpPr>
        <p:spPr>
          <a:xfrm rot="9000000">
            <a:off x="2384277" y="3920403"/>
            <a:ext cx="340797" cy="26633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259BF63-3A63-A498-E65E-6740F56B3A1E}"/>
              </a:ext>
            </a:extLst>
          </p:cNvPr>
          <p:cNvSpPr txBox="1"/>
          <p:nvPr/>
        </p:nvSpPr>
        <p:spPr>
          <a:xfrm>
            <a:off x="616040" y="5791433"/>
            <a:ext cx="79484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mages shown are the maximum intensity projection (MIP) image of [</a:t>
            </a:r>
            <a:r>
              <a:rPr kumimoji="1" lang="en-US" altLang="ja-JP" baseline="30000" dirty="0"/>
              <a:t>18</a:t>
            </a:r>
            <a:r>
              <a:rPr kumimoji="1" lang="en-US" altLang="ja-JP" dirty="0"/>
              <a:t>F]FIMP after irradiation. Tumors on right paws, as indicated by arrows, were irradiated on day 0 at the dose of 60 </a:t>
            </a:r>
            <a:r>
              <a:rPr kumimoji="1" lang="en-US" altLang="ja-JP" dirty="0" err="1"/>
              <a:t>Gy</a:t>
            </a:r>
            <a:r>
              <a:rPr kumimoji="1" lang="en-US" altLang="ja-JP" dirty="0"/>
              <a:t>. PET data were acquired 90 min after injection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77893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B5692664-8562-0C8F-9674-52C093056489}"/>
              </a:ext>
            </a:extLst>
          </p:cNvPr>
          <p:cNvGrpSpPr>
            <a:grpSpLocks noChangeAspect="1"/>
          </p:cNvGrpSpPr>
          <p:nvPr/>
        </p:nvGrpSpPr>
        <p:grpSpPr>
          <a:xfrm>
            <a:off x="615967" y="381740"/>
            <a:ext cx="7905841" cy="5400000"/>
            <a:chOff x="71024" y="381740"/>
            <a:chExt cx="8968140" cy="6125592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EBC3739B-9169-B6CD-D86D-16C21FC8117B}"/>
                </a:ext>
              </a:extLst>
            </p:cNvPr>
            <p:cNvSpPr/>
            <p:nvPr/>
          </p:nvSpPr>
          <p:spPr>
            <a:xfrm>
              <a:off x="71024" y="381740"/>
              <a:ext cx="8968140" cy="612559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0D85CDC-527F-33D3-9AE7-1416C96EF9B1}"/>
                </a:ext>
              </a:extLst>
            </p:cNvPr>
            <p:cNvSpPr txBox="1"/>
            <p:nvPr/>
          </p:nvSpPr>
          <p:spPr>
            <a:xfrm>
              <a:off x="1337536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8DB04A6-F983-E5A8-1849-EC05FDCDB6B4}"/>
                </a:ext>
              </a:extLst>
            </p:cNvPr>
            <p:cNvSpPr txBox="1"/>
            <p:nvPr/>
          </p:nvSpPr>
          <p:spPr>
            <a:xfrm>
              <a:off x="2812298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3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6799821-3B3C-C723-1896-E5694C04B6C4}"/>
                </a:ext>
              </a:extLst>
            </p:cNvPr>
            <p:cNvSpPr txBox="1"/>
            <p:nvPr/>
          </p:nvSpPr>
          <p:spPr>
            <a:xfrm>
              <a:off x="4342988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7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D84C0F3-C18D-0599-687C-142B85CBB2BD}"/>
                </a:ext>
              </a:extLst>
            </p:cNvPr>
            <p:cNvSpPr txBox="1"/>
            <p:nvPr/>
          </p:nvSpPr>
          <p:spPr>
            <a:xfrm>
              <a:off x="5742619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0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BC53430-5D7F-F82F-4DB3-A2D53EAF13E5}"/>
                </a:ext>
              </a:extLst>
            </p:cNvPr>
            <p:cNvSpPr txBox="1"/>
            <p:nvPr/>
          </p:nvSpPr>
          <p:spPr>
            <a:xfrm>
              <a:off x="7228400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4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B3D5708-62D0-D91B-5DA0-68D28465655F}"/>
                </a:ext>
              </a:extLst>
            </p:cNvPr>
            <p:cNvSpPr txBox="1"/>
            <p:nvPr/>
          </p:nvSpPr>
          <p:spPr>
            <a:xfrm>
              <a:off x="168916" y="481406"/>
              <a:ext cx="947943" cy="349702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b="1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r>
                <a:rPr kumimoji="1" lang="en-US" altLang="ja-JP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-FDG</a:t>
              </a:r>
              <a:endParaRPr kumimoji="1" lang="ja-JP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198195AE-D150-C50B-7880-D453887A9AA0}"/>
                </a:ext>
              </a:extLst>
            </p:cNvPr>
            <p:cNvGrpSpPr/>
            <p:nvPr/>
          </p:nvGrpSpPr>
          <p:grpSpPr>
            <a:xfrm>
              <a:off x="8446019" y="4774699"/>
              <a:ext cx="428771" cy="1465757"/>
              <a:chOff x="7726932" y="4295304"/>
              <a:chExt cx="428771" cy="1465757"/>
            </a:xfrm>
          </p:grpSpPr>
          <p:pic>
            <p:nvPicPr>
              <p:cNvPr id="29" name="図 28" descr="color bar.bmp">
                <a:extLst>
                  <a:ext uri="{FF2B5EF4-FFF2-40B4-BE49-F238E27FC236}">
                    <a16:creationId xmlns:a16="http://schemas.microsoft.com/office/drawing/2014/main" id="{0CD46348-A095-32EA-1E23-2296F8FBF3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 rot="16200000">
                <a:off x="7481317" y="5046387"/>
                <a:ext cx="920001" cy="69241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2E6FF59-55BD-8AE7-CE5B-734403C9E2AA}"/>
                  </a:ext>
                </a:extLst>
              </p:cNvPr>
              <p:cNvSpPr txBox="1"/>
              <p:nvPr/>
            </p:nvSpPr>
            <p:spPr>
              <a:xfrm>
                <a:off x="7773818" y="5532537"/>
                <a:ext cx="334996" cy="228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0.2</a:t>
                </a:r>
                <a:endParaRPr lang="ja-JP" altLang="en-US" sz="1050" b="1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64E89EB3-6D9F-BC70-3C1F-B06EA9812D18}"/>
                  </a:ext>
                </a:extLst>
              </p:cNvPr>
              <p:cNvSpPr txBox="1"/>
              <p:nvPr/>
            </p:nvSpPr>
            <p:spPr>
              <a:xfrm>
                <a:off x="7773818" y="4416755"/>
                <a:ext cx="334996" cy="2285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2.0</a:t>
                </a:r>
                <a:endParaRPr lang="ja-JP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90F71730-7397-62F2-5081-F52ED2A41523}"/>
                  </a:ext>
                </a:extLst>
              </p:cNvPr>
              <p:cNvSpPr txBox="1"/>
              <p:nvPr/>
            </p:nvSpPr>
            <p:spPr>
              <a:xfrm>
                <a:off x="7726932" y="4295304"/>
                <a:ext cx="428771" cy="2354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10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SUV</a:t>
                </a:r>
                <a:endParaRPr lang="ja-JP" altLang="en-US" sz="110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9" name="Picture 3" descr="F:\NagasePJ\X線照射\FDG\Day1\160422_Mouse_Body_A03115_GPP0027_Day1-Con_nozaki_F2A\Analysis\160422_Mouse_Body_A03115_GPP0027_Day1-Con_nozaki_F2A_v1_sta_OSEM_ACNoSC_MIP.img_f0_x64_y0_z47_coro SUV0.2-2.0.tif">
              <a:extLst>
                <a:ext uri="{FF2B5EF4-FFF2-40B4-BE49-F238E27FC236}">
                  <a16:creationId xmlns:a16="http://schemas.microsoft.com/office/drawing/2014/main" id="{5E361CF3-2172-FAD8-8A4B-76C052D8D6F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8510" y="1279390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5" descr="F:\NagasePJ\X線照射\FDG\Day1\160531_Mouse_Body_A03165_GPP0027_Day1-60Gy_nozaki_F2A\Analysis\160531_Mouse_Body_A03165_GPP0027_Day1-60Gy_nozaki_F2A_v1_sta_OSEM_ACNoSC_MIP.img_f0_x64_y0_z47_coro SUV0.2-2.0.tif">
              <a:extLst>
                <a:ext uri="{FF2B5EF4-FFF2-40B4-BE49-F238E27FC236}">
                  <a16:creationId xmlns:a16="http://schemas.microsoft.com/office/drawing/2014/main" id="{AF54B024-FB76-8045-B73E-794F027BD94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8510" y="4077071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6" descr="F:\NagasePJ\X線照射\FDG\Day3\160422_Mouse_Body_A03116_GPP0027_Day3-Con_nozaki_F2B\Analysis\160422_Mouse_Body_A03116_GPP0027_Day3-Con_nozaki_F2B_v1_sta_OSEM_ACNoSC_MIP.img_f0_x64_y0_z47_coro SUV0.2-2.0.tif">
              <a:extLst>
                <a:ext uri="{FF2B5EF4-FFF2-40B4-BE49-F238E27FC236}">
                  <a16:creationId xmlns:a16="http://schemas.microsoft.com/office/drawing/2014/main" id="{7D15AB37-4120-9838-64DE-DB4A6570FDB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2051" y="1279390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" name="Picture 8" descr="F:\NagasePJ\X線照射\FDG\Day3\160606_Mouse_Body_A03174_GPP0027_Day3-60Gy_nozaki_F2B\Analysis\160606_Mouse_Body_A03174_GPP0027_Day3-60Gy_nozaki_F2B_v1_sta_OSEM_ACNoSC_MIP.img_f0_x64_y0_z47_coro SUV0.2-2.0.tif">
              <a:extLst>
                <a:ext uri="{FF2B5EF4-FFF2-40B4-BE49-F238E27FC236}">
                  <a16:creationId xmlns:a16="http://schemas.microsoft.com/office/drawing/2014/main" id="{C988739F-E710-6B70-4E54-8F2B50A70D8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2051" y="4077071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11" descr="F:\NagasePJ\X線照射\FDG\Day7\160422_Mouse_Body_A03119_GPP0027_Day7-Con_nozaki_F2A\Analysis\160422_Mouse_Body_A03119_GPP0027_Day7-Con_nozaki_F2A_v1_sta_OSEM_ACNoSC_MIP.img_f0_x64_y0_z47_coro SUV0.2-2.0.tif">
              <a:extLst>
                <a:ext uri="{FF2B5EF4-FFF2-40B4-BE49-F238E27FC236}">
                  <a16:creationId xmlns:a16="http://schemas.microsoft.com/office/drawing/2014/main" id="{930DEAFE-A834-946E-FCCA-03F49BA51C9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53962" y="1279390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6" name="Picture 13" descr="F:\NagasePJ\X線照射\FDG\Day7\160531_Mouse_Body_A03163_GPP0027_Day7-60Gy_nozaki_F2A\Analysis\160531_Mouse_Body_A03163_GPP0027_Day7-60Gy_nozaki_F2A_v1_sta_OSEM_ACNoSC_MIP.img_f0_x64_y0_z47_coro SUV0.2-2.0.tif">
              <a:extLst>
                <a:ext uri="{FF2B5EF4-FFF2-40B4-BE49-F238E27FC236}">
                  <a16:creationId xmlns:a16="http://schemas.microsoft.com/office/drawing/2014/main" id="{A80A6B0A-3BDA-7211-C727-F02EAB967A7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53962" y="4077071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7" name="Picture 15" descr="F:\NagasePJ\X線照射\FDG\Day10\160512_Mouse_Body_A03147_GPP0027_Day10-Con_nozaki_F2A\Analysis\160512_Mouse_Body_A03147_GPP0027_Day10-Con_nozaki_F2A_v1_sta_OSEM_ACNoSC_MIP.img_f0_x64_y0_z47_coro SUV0.2-2.0.tif">
              <a:extLst>
                <a:ext uri="{FF2B5EF4-FFF2-40B4-BE49-F238E27FC236}">
                  <a16:creationId xmlns:a16="http://schemas.microsoft.com/office/drawing/2014/main" id="{FF43BEA1-2041-B5B2-4314-22D87EFC527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12103" y="1279390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8" name="Picture 16" descr="F:\NagasePJ\X線照射\FDG\Day10\160606_Mouse_Body_A03176_GPP0027_Day10-60Gy_nozaki_F2B\Analysis\160606_Mouse_Body_A03176_GPP0027_Day10-60Gy_nozaki_F2B_v1_sta_OSEM_ACNoSC_MIP.img_f0_x64_y0_z47_coro SUV0.2-2.0.tif">
              <a:extLst>
                <a:ext uri="{FF2B5EF4-FFF2-40B4-BE49-F238E27FC236}">
                  <a16:creationId xmlns:a16="http://schemas.microsoft.com/office/drawing/2014/main" id="{3B575121-D83B-E673-4162-DF798ABAFCA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12103" y="4077071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4" name="Picture 18" descr="F:\NagasePJ\X線照射\FDG\Day14\160512_Mouse_Body_A03148_GPP0027_Day14-Con_nozaki_F2B\Analysis\160512_Mouse_Body_A03148_GPP0027_Day14-Con_nozaki_F2B_v1_sta_OSEM_ACNoSC_MIP.img_f0_x64_y0_z47_coro SUV0.2-2.0.tif">
              <a:extLst>
                <a:ext uri="{FF2B5EF4-FFF2-40B4-BE49-F238E27FC236}">
                  <a16:creationId xmlns:a16="http://schemas.microsoft.com/office/drawing/2014/main" id="{87AE597A-6CDE-44F9-1059-1F1AD86DC44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97884" y="1279390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5" name="Picture 21" descr="F:\NagasePJ\X線照射\FDG\Day14\160531_Mouse_Body_A03161_GPP0027_Day14-60Gy_nozaki_F2A\Analysis\160531_Mouse_Body_A03161_GPP0027_Day14-60Gy_nozaki_F2A_v1_sta_OSEM_ACNoSC_MIP.img_f0_x64_y0_z47_coro SUV0.2-2.0.tif">
              <a:extLst>
                <a:ext uri="{FF2B5EF4-FFF2-40B4-BE49-F238E27FC236}">
                  <a16:creationId xmlns:a16="http://schemas.microsoft.com/office/drawing/2014/main" id="{10B5255C-E128-B975-0679-50236EA1126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97884" y="4077071"/>
              <a:ext cx="1767021" cy="2206800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99A477B-8DF1-C002-CEEB-178C23D2A4D5}"/>
                </a:ext>
              </a:extLst>
            </p:cNvPr>
            <p:cNvSpPr txBox="1"/>
            <p:nvPr/>
          </p:nvSpPr>
          <p:spPr>
            <a:xfrm>
              <a:off x="388426" y="1651075"/>
              <a:ext cx="42321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Con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F29236C-39AC-B710-3E2C-99167DB17E69}"/>
                </a:ext>
              </a:extLst>
            </p:cNvPr>
            <p:cNvSpPr txBox="1"/>
            <p:nvPr/>
          </p:nvSpPr>
          <p:spPr>
            <a:xfrm>
              <a:off x="303215" y="4479516"/>
              <a:ext cx="54164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60Gy</a:t>
              </a:r>
            </a:p>
          </p:txBody>
        </p: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763301A-C2A8-1373-AB4E-5ADC6AB32659}"/>
              </a:ext>
            </a:extLst>
          </p:cNvPr>
          <p:cNvSpPr txBox="1"/>
          <p:nvPr/>
        </p:nvSpPr>
        <p:spPr>
          <a:xfrm>
            <a:off x="0" y="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0" dirty="0">
                <a:solidFill>
                  <a:srgbClr val="222222"/>
                </a:solidFill>
                <a:effectLst/>
                <a:latin typeface="-apple-system"/>
              </a:rPr>
              <a:t>Supplementary Figure S2</a:t>
            </a:r>
            <a:endParaRPr kumimoji="1" lang="ja-JP" altLang="en-US" b="1" dirty="0"/>
          </a:p>
        </p:txBody>
      </p:sp>
      <p:sp>
        <p:nvSpPr>
          <p:cNvPr id="9" name="矢印: 右 8">
            <a:extLst>
              <a:ext uri="{FF2B5EF4-FFF2-40B4-BE49-F238E27FC236}">
                <a16:creationId xmlns:a16="http://schemas.microsoft.com/office/drawing/2014/main" id="{87552868-6604-AEB7-4329-07A4D557EF31}"/>
              </a:ext>
            </a:extLst>
          </p:cNvPr>
          <p:cNvSpPr/>
          <p:nvPr/>
        </p:nvSpPr>
        <p:spPr>
          <a:xfrm rot="9000000">
            <a:off x="2456834" y="1659809"/>
            <a:ext cx="340797" cy="26633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矢印: 右 9">
            <a:extLst>
              <a:ext uri="{FF2B5EF4-FFF2-40B4-BE49-F238E27FC236}">
                <a16:creationId xmlns:a16="http://schemas.microsoft.com/office/drawing/2014/main" id="{5ADA3C3B-68AB-D5C4-2CB6-559F1DB22270}"/>
              </a:ext>
            </a:extLst>
          </p:cNvPr>
          <p:cNvSpPr/>
          <p:nvPr/>
        </p:nvSpPr>
        <p:spPr>
          <a:xfrm rot="9000000">
            <a:off x="2368975" y="3974313"/>
            <a:ext cx="340797" cy="266330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763E02D-F66B-A72C-5B2B-642887EF0673}"/>
              </a:ext>
            </a:extLst>
          </p:cNvPr>
          <p:cNvSpPr txBox="1"/>
          <p:nvPr/>
        </p:nvSpPr>
        <p:spPr>
          <a:xfrm>
            <a:off x="616040" y="5791433"/>
            <a:ext cx="79484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mages shown are the maximum intensity projection (MIP) image of [</a:t>
            </a:r>
            <a:r>
              <a:rPr kumimoji="1" lang="en-US" altLang="ja-JP" baseline="30000" dirty="0"/>
              <a:t>18</a:t>
            </a:r>
            <a:r>
              <a:rPr kumimoji="1" lang="en-US" altLang="ja-JP" dirty="0"/>
              <a:t>F]FDG after irradiation. Tumors on right paws, as indicated by arrows, were irradiated on day 0 at the dose of 60 </a:t>
            </a:r>
            <a:r>
              <a:rPr kumimoji="1" lang="en-US" altLang="ja-JP" dirty="0" err="1"/>
              <a:t>Gy</a:t>
            </a:r>
            <a:r>
              <a:rPr kumimoji="1" lang="en-US" altLang="ja-JP" dirty="0"/>
              <a:t>. PET data were acquired 55 to 100 min after injection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72176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565C0C8-78C5-0D48-6AC7-40A77169BDE2}"/>
              </a:ext>
            </a:extLst>
          </p:cNvPr>
          <p:cNvSpPr txBox="1"/>
          <p:nvPr/>
        </p:nvSpPr>
        <p:spPr>
          <a:xfrm>
            <a:off x="0" y="0"/>
            <a:ext cx="2564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i="0" dirty="0">
                <a:solidFill>
                  <a:srgbClr val="222222"/>
                </a:solidFill>
                <a:effectLst/>
                <a:latin typeface="-apple-system"/>
              </a:rPr>
              <a:t>Supplementary Figure S3</a:t>
            </a:r>
            <a:endParaRPr kumimoji="1" lang="ja-JP" altLang="en-US" b="1" dirty="0"/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04F94611-066F-66FB-C6D2-E8485FA6E5CE}"/>
              </a:ext>
            </a:extLst>
          </p:cNvPr>
          <p:cNvGrpSpPr>
            <a:grpSpLocks noChangeAspect="1"/>
          </p:cNvGrpSpPr>
          <p:nvPr/>
        </p:nvGrpSpPr>
        <p:grpSpPr>
          <a:xfrm>
            <a:off x="615965" y="381740"/>
            <a:ext cx="7905841" cy="5400000"/>
            <a:chOff x="71024" y="381740"/>
            <a:chExt cx="8968140" cy="6125592"/>
          </a:xfrm>
        </p:grpSpPr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EBC3739B-9169-B6CD-D86D-16C21FC8117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1024" y="381740"/>
              <a:ext cx="8968140" cy="6125592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0D85CDC-527F-33D3-9AE7-1416C96EF9B1}"/>
                </a:ext>
              </a:extLst>
            </p:cNvPr>
            <p:cNvSpPr txBox="1"/>
            <p:nvPr/>
          </p:nvSpPr>
          <p:spPr>
            <a:xfrm>
              <a:off x="1425213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58DB04A6-F983-E5A8-1849-EC05FDCDB6B4}"/>
                </a:ext>
              </a:extLst>
            </p:cNvPr>
            <p:cNvSpPr txBox="1"/>
            <p:nvPr/>
          </p:nvSpPr>
          <p:spPr>
            <a:xfrm>
              <a:off x="2893266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3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6799821-3B3C-C723-1896-E5694C04B6C4}"/>
                </a:ext>
              </a:extLst>
            </p:cNvPr>
            <p:cNvSpPr txBox="1"/>
            <p:nvPr/>
          </p:nvSpPr>
          <p:spPr>
            <a:xfrm>
              <a:off x="4362865" y="731235"/>
              <a:ext cx="588969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7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D84C0F3-C18D-0599-687C-142B85CBB2BD}"/>
                </a:ext>
              </a:extLst>
            </p:cNvPr>
            <p:cNvSpPr txBox="1"/>
            <p:nvPr/>
          </p:nvSpPr>
          <p:spPr>
            <a:xfrm>
              <a:off x="5773955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0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BC53430-5D7F-F82F-4DB3-A2D53EAF13E5}"/>
                </a:ext>
              </a:extLst>
            </p:cNvPr>
            <p:cNvSpPr txBox="1"/>
            <p:nvPr/>
          </p:nvSpPr>
          <p:spPr>
            <a:xfrm>
              <a:off x="7243554" y="731235"/>
              <a:ext cx="70598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ay 14</a:t>
              </a:r>
              <a:endParaRPr lang="ja-JP" altLang="en-US" b="1" dirty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pic>
          <p:nvPicPr>
            <p:cNvPr id="7" name="Picture 2" descr="F:\NagasePJ\X線照射\MET\Day 1\160601_Mouse_Body_A03170_GPP0032_Day1-Con_nozaki_F2B\Analysis\SUM10-40 160601_Mouse_Body_A03170_GPP0032_Day1-Con_nozaki_F2B_v1_dy_OSEM_ACNoSC_MIP.img_f0_x64_y0_z47_coro SUV0-1.5.tif">
              <a:extLst>
                <a:ext uri="{FF2B5EF4-FFF2-40B4-BE49-F238E27FC236}">
                  <a16:creationId xmlns:a16="http://schemas.microsoft.com/office/drawing/2014/main" id="{178AC1FC-4A3C-38C6-8CC9-6189CF2B8F2E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53" y="1273439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4" descr="F:\NagasePJ\X線照射\MET\Day 1\160712_Mouse_Body_A03257_GPP0032_Day1-60Gy_nozaki_F2B\Analysis\SUM10-40 160712_Mouse_Body_A03257_GPP0032_Day1-60Gy_nozaki_F2B_v1_dy_OSEM_ACNoSC_MIP.img_f0_x64_y0_z47_coro SUV0-1.5.tif">
              <a:extLst>
                <a:ext uri="{FF2B5EF4-FFF2-40B4-BE49-F238E27FC236}">
                  <a16:creationId xmlns:a16="http://schemas.microsoft.com/office/drawing/2014/main" id="{2C291D45-3325-0055-AB59-078EF1B5DD2C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35953" y="4023046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6" descr="F:\NagasePJ\X線照射\MET\Day 3\160602_Mouse_Body_A03172_GPP0032_Day3-Con_nozaki_F2B\Analysis\SUM10-40 160602_Mouse_Body_A03172_GPP0032_Day3-Con_nozaki_F2B_v1_dy_OSEM_ACNoSC_MIP.img_f0_x64_y0_z47_coro SUV0-1.5.tif">
              <a:extLst>
                <a:ext uri="{FF2B5EF4-FFF2-40B4-BE49-F238E27FC236}">
                  <a16:creationId xmlns:a16="http://schemas.microsoft.com/office/drawing/2014/main" id="{4B1B55CC-7EF3-65F5-9082-3BC41A144029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04006" y="1273439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9" descr="F:\NagasePJ\X線照射\MET\Day 7\160628_Mouse_Body_A03207_GPP0032_Day7-Con_nozaki_F2A\Analysis\SUM10-40 160628_Mouse_Body_A03207_GPP0032_Day7-Con_nozaki_F2A_v1_dy_OSEM_ACNoSC_MIP.img_f0_x64_y0_z47_coro SUV0-1.5.tif">
              <a:extLst>
                <a:ext uri="{FF2B5EF4-FFF2-40B4-BE49-F238E27FC236}">
                  <a16:creationId xmlns:a16="http://schemas.microsoft.com/office/drawing/2014/main" id="{A72DE7EF-998D-3EE3-C510-D394BD546355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3605" y="1273439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10" descr="F:\NagasePJ\X線照射\MET\Day 7\160613_Mouse_Body_A03188_GPP0032_Day7-60Gy_nozaki_F2B\Analysis\SUM10-40 160613_Mouse_Body_A03188_GPP0032_Day7-60Gy_nozaki_F2B_v1_dy_OSEM_ACNoSC_MIP.img_f0_x64_y0_z47_coro SUV0-1.5.tif">
              <a:extLst>
                <a:ext uri="{FF2B5EF4-FFF2-40B4-BE49-F238E27FC236}">
                  <a16:creationId xmlns:a16="http://schemas.microsoft.com/office/drawing/2014/main" id="{DD4CABCD-895E-C942-8822-3E9A61CA6FC8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73605" y="4023046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3" descr="F:\NagasePJ\X線照射\MET\Day 10\160801_Mouse_Body_A03298_GPP0032_Day10-60Gy_nozaki_F2B\Analysis\SUM10-40 160801_Mouse_Body_A03298_GPP0032_Day10-60Gy_nozaki_F2B_v1_dy_OSEM_ACNoSC_MIP.img_f0_x64_y0_z47_coro SUV0-1.5.tif">
              <a:extLst>
                <a:ext uri="{FF2B5EF4-FFF2-40B4-BE49-F238E27FC236}">
                  <a16:creationId xmlns:a16="http://schemas.microsoft.com/office/drawing/2014/main" id="{B0986FE0-63E8-7A5F-EF6D-5024AC218A3A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3205" y="4023046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15" descr="F:\NagasePJ\X線照射\MET\Day 14\160622_Mouse_Body_A03202_GPP0032_Day14-Con_nozaki_F2B\Analysis\SUM10-40 160622_Mouse_Body_A03202_GPP0032_Day14-Con_nozaki_F2B_v1_dy_OSEM_ACNoSC_MIP.img_f0_x64_y0_z47_coro SUV0-1.5.tif">
              <a:extLst>
                <a:ext uri="{FF2B5EF4-FFF2-40B4-BE49-F238E27FC236}">
                  <a16:creationId xmlns:a16="http://schemas.microsoft.com/office/drawing/2014/main" id="{81886E57-3E10-2A06-17CA-3B56C4E1FCFB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12804" y="1273439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17" descr="F:\NagasePJ\X線照射\MET\Day 14\160620_Mouse_Body_A03200_GPP0032_Day14-60Gy_nozaki_F2B\Analysis\SUM10-40 160620_Mouse_Body_A03200_GPP0032_Day14-60Gy_nozaki_F2B_v1_dy_OSEM_ACNoSC_MIP.img_f0_x64_y0_z47_coro SUV0-1.5.tif">
              <a:extLst>
                <a:ext uri="{FF2B5EF4-FFF2-40B4-BE49-F238E27FC236}">
                  <a16:creationId xmlns:a16="http://schemas.microsoft.com/office/drawing/2014/main" id="{E12C6C53-C31D-AB74-0344-AADFA7A99748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12804" y="4023046"/>
              <a:ext cx="1767489" cy="2207403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99A477B-8DF1-C002-CEEB-178C23D2A4D5}"/>
                </a:ext>
              </a:extLst>
            </p:cNvPr>
            <p:cNvSpPr txBox="1"/>
            <p:nvPr/>
          </p:nvSpPr>
          <p:spPr>
            <a:xfrm>
              <a:off x="412735" y="1651075"/>
              <a:ext cx="42321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Con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F29236C-39AC-B710-3E2C-99167DB17E69}"/>
                </a:ext>
              </a:extLst>
            </p:cNvPr>
            <p:cNvSpPr txBox="1"/>
            <p:nvPr/>
          </p:nvSpPr>
          <p:spPr>
            <a:xfrm>
              <a:off x="327524" y="4479516"/>
              <a:ext cx="541648" cy="331526"/>
            </a:xfrm>
            <a:prstGeom prst="rect">
              <a:avLst/>
            </a:prstGeom>
            <a:noFill/>
          </p:spPr>
          <p:txBody>
            <a:bodyPr wrap="none" lIns="27000" tIns="27000" rIns="27000" bIns="27000" rtlCol="0">
              <a:spAutoFit/>
            </a:bodyPr>
            <a:lstStyle/>
            <a:p>
              <a:pPr algn="ctr"/>
              <a:r>
                <a:rPr lang="en-US" altLang="ja-JP" b="1" dirty="0">
                  <a:solidFill>
                    <a:schemeClr val="bg1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60Gy</a:t>
              </a:r>
            </a:p>
          </p:txBody>
        </p:sp>
        <p:pic>
          <p:nvPicPr>
            <p:cNvPr id="17" name="Picture 2" descr="F:\NagasePJ\X線照射\MET\Day 3\160804_Mouse_Body_A03310_GPP0032_Day3-60Gy_nozaki_F2B\Analysis\SUM10-40 160804_Mouse_Body_A03310_GPP0032_Day3-60Gy_nozaki_F2B_v1_dy_OSEM_ACNoSC_MIP.img_f0_x64_y0_z47_coro SUV0-1.5.tif">
              <a:extLst>
                <a:ext uri="{FF2B5EF4-FFF2-40B4-BE49-F238E27FC236}">
                  <a16:creationId xmlns:a16="http://schemas.microsoft.com/office/drawing/2014/main" id="{8B1268EB-5C65-0C47-9835-0BFE737EBC88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03232" y="4023060"/>
              <a:ext cx="1769036" cy="2206435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2" descr="F:\NagasePJ\X線照射\MET\Day 10\160822_Mouse_Body_A03324_GPP0032_Day10-Con_nozaki_F2B\Analysys\SUM10-40 160822_Mouse_Body_A03324_GPP0032_Day10-Con_nozaki_F2B_v1_dy_OSEM_ACNoSC_MIP.img_f0_x64_y0_z47_coro SUV0-1.5.tif">
              <a:extLst>
                <a:ext uri="{FF2B5EF4-FFF2-40B4-BE49-F238E27FC236}">
                  <a16:creationId xmlns:a16="http://schemas.microsoft.com/office/drawing/2014/main" id="{66F7A522-195E-3F53-9665-476171DD806A}"/>
                </a:ext>
              </a:extLst>
            </p:cNvPr>
            <p:cNvPicPr preferRelativeResize="0"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42431" y="1273453"/>
              <a:ext cx="1769036" cy="2206435"/>
            </a:xfrm>
            <a:prstGeom prst="rect">
              <a:avLst/>
            </a:prstGeom>
            <a:noFill/>
            <a:ln w="381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8B3D5708-62D0-D91B-5DA0-68D28465655F}"/>
                </a:ext>
              </a:extLst>
            </p:cNvPr>
            <p:cNvSpPr txBox="1"/>
            <p:nvPr/>
          </p:nvSpPr>
          <p:spPr>
            <a:xfrm>
              <a:off x="168916" y="481406"/>
              <a:ext cx="965127" cy="349702"/>
            </a:xfrm>
            <a:prstGeom prst="rect">
              <a:avLst/>
            </a:prstGeom>
            <a:noFill/>
          </p:spPr>
          <p:txBody>
            <a:bodyPr wrap="none" lIns="36000" tIns="36000" rIns="36000" bIns="36000" rtlCol="0">
              <a:spAutoFit/>
            </a:bodyPr>
            <a:lstStyle/>
            <a:p>
              <a:r>
                <a:rPr kumimoji="1" lang="en-US" altLang="ja-JP" b="1" baseline="30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r>
                <a:rPr kumimoji="1" lang="en-US" altLang="ja-JP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-MET</a:t>
              </a:r>
              <a:endParaRPr kumimoji="1" lang="ja-JP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198195AE-D150-C50B-7880-D453887A9AA0}"/>
                </a:ext>
              </a:extLst>
            </p:cNvPr>
            <p:cNvGrpSpPr/>
            <p:nvPr/>
          </p:nvGrpSpPr>
          <p:grpSpPr>
            <a:xfrm>
              <a:off x="8446019" y="4774699"/>
              <a:ext cx="428771" cy="1491149"/>
              <a:chOff x="7726932" y="4295304"/>
              <a:chExt cx="428771" cy="1491149"/>
            </a:xfrm>
          </p:grpSpPr>
          <p:pic>
            <p:nvPicPr>
              <p:cNvPr id="29" name="図 28" descr="color bar.bmp">
                <a:extLst>
                  <a:ext uri="{FF2B5EF4-FFF2-40B4-BE49-F238E27FC236}">
                    <a16:creationId xmlns:a16="http://schemas.microsoft.com/office/drawing/2014/main" id="{0CD46348-A095-32EA-1E23-2296F8FBF3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/>
              <a:stretch>
                <a:fillRect/>
              </a:stretch>
            </p:blipFill>
            <p:spPr>
              <a:xfrm rot="16200000">
                <a:off x="7481317" y="5046387"/>
                <a:ext cx="920001" cy="69241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B2E6FF59-55BD-8AE7-CE5B-734403C9E2AA}"/>
                  </a:ext>
                </a:extLst>
              </p:cNvPr>
              <p:cNvSpPr txBox="1"/>
              <p:nvPr/>
            </p:nvSpPr>
            <p:spPr>
              <a:xfrm>
                <a:off x="7811312" y="5532537"/>
                <a:ext cx="2600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64E89EB3-6D9F-BC70-3C1F-B06EA9812D18}"/>
                  </a:ext>
                </a:extLst>
              </p:cNvPr>
              <p:cNvSpPr txBox="1"/>
              <p:nvPr/>
            </p:nvSpPr>
            <p:spPr>
              <a:xfrm>
                <a:off x="7755208" y="4416755"/>
                <a:ext cx="37221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050" b="1" dirty="0">
                    <a:solidFill>
                      <a:schemeClr val="bg1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.5</a:t>
                </a:r>
                <a:endParaRPr lang="ja-JP" altLang="en-US" sz="105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90F71730-7397-62F2-5081-F52ED2A41523}"/>
                  </a:ext>
                </a:extLst>
              </p:cNvPr>
              <p:cNvSpPr txBox="1"/>
              <p:nvPr/>
            </p:nvSpPr>
            <p:spPr>
              <a:xfrm>
                <a:off x="7726932" y="4295304"/>
                <a:ext cx="428771" cy="2354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ja-JP" sz="1100" b="1" dirty="0">
                    <a:solidFill>
                      <a:schemeClr val="bg1"/>
                    </a:solidFill>
                    <a:latin typeface="Arial" panose="020B0604020202020204" pitchFamily="34" charset="0"/>
                    <a:ea typeface="Segoe UI" panose="020B0502040204020203" pitchFamily="34" charset="0"/>
                    <a:cs typeface="Arial" panose="020B0604020202020204" pitchFamily="34" charset="0"/>
                  </a:rPr>
                  <a:t>SUV</a:t>
                </a:r>
                <a:endParaRPr lang="ja-JP" altLang="en-US" sz="1100" b="1" dirty="0">
                  <a:solidFill>
                    <a:schemeClr val="bg1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0" name="矢印: 右 19">
              <a:extLst>
                <a:ext uri="{FF2B5EF4-FFF2-40B4-BE49-F238E27FC236}">
                  <a16:creationId xmlns:a16="http://schemas.microsoft.com/office/drawing/2014/main" id="{D01528DA-1798-FB31-AF7A-DCC5AE3EBDE3}"/>
                </a:ext>
              </a:extLst>
            </p:cNvPr>
            <p:cNvSpPr/>
            <p:nvPr/>
          </p:nvSpPr>
          <p:spPr>
            <a:xfrm rot="9000000">
              <a:off x="2217345" y="1718435"/>
              <a:ext cx="340797" cy="26633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1" name="矢印: 右 20">
              <a:extLst>
                <a:ext uri="{FF2B5EF4-FFF2-40B4-BE49-F238E27FC236}">
                  <a16:creationId xmlns:a16="http://schemas.microsoft.com/office/drawing/2014/main" id="{6315FC8D-E7C0-6541-CC77-301710018DBC}"/>
                </a:ext>
              </a:extLst>
            </p:cNvPr>
            <p:cNvSpPr/>
            <p:nvPr/>
          </p:nvSpPr>
          <p:spPr>
            <a:xfrm rot="9000000">
              <a:off x="2284173" y="4239376"/>
              <a:ext cx="340797" cy="266330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6DA9E49-5C78-BE99-6E74-36BEC3FFBF8B}"/>
              </a:ext>
            </a:extLst>
          </p:cNvPr>
          <p:cNvSpPr txBox="1"/>
          <p:nvPr/>
        </p:nvSpPr>
        <p:spPr>
          <a:xfrm>
            <a:off x="616040" y="5791433"/>
            <a:ext cx="794847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Images shown are the maximum intensity projection (MIP) image of [</a:t>
            </a:r>
            <a:r>
              <a:rPr kumimoji="1" lang="en-US" altLang="ja-JP" baseline="30000" dirty="0"/>
              <a:t>11</a:t>
            </a:r>
            <a:r>
              <a:rPr kumimoji="1" lang="en-US" altLang="ja-JP" dirty="0"/>
              <a:t>C]MET after irradiation. Tumors on right paws, as indicated by arrows, were irradiated on day 0 at the dose of 60 </a:t>
            </a:r>
            <a:r>
              <a:rPr kumimoji="1" lang="en-US" altLang="ja-JP" dirty="0" err="1"/>
              <a:t>Gy</a:t>
            </a:r>
            <a:r>
              <a:rPr kumimoji="1" lang="en-US" altLang="ja-JP" dirty="0"/>
              <a:t>. PET data were acquired 90 min after injection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9840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266</Words>
  <Application>Microsoft Office PowerPoint</Application>
  <PresentationFormat>画面に合わせる (4:3)</PresentationFormat>
  <Paragraphs>4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-apple-system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Nozaki</dc:creator>
  <cp:lastModifiedBy>Satoshi Nozaki</cp:lastModifiedBy>
  <cp:revision>6</cp:revision>
  <dcterms:created xsi:type="dcterms:W3CDTF">2022-11-13T07:09:00Z</dcterms:created>
  <dcterms:modified xsi:type="dcterms:W3CDTF">2023-01-17T12:48:42Z</dcterms:modified>
</cp:coreProperties>
</file>